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  <p:sldId id="260" r:id="rId5"/>
    <p:sldId id="262" r:id="rId6"/>
    <p:sldId id="263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916"/>
    <p:restoredTop sz="95897"/>
  </p:normalViewPr>
  <p:slideViewPr>
    <p:cSldViewPr snapToGrid="0">
      <p:cViewPr varScale="1">
        <p:scale>
          <a:sx n="50" d="100"/>
          <a:sy n="50" d="100"/>
        </p:scale>
        <p:origin x="43" y="8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D4234E-4B8E-E2F5-3AF5-CD0394E3660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15A7ECE-0E8B-336C-4313-2F9EC858FD2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85A4E9-0FFF-EFA8-58F3-93BD0A4900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E2EDF-C2EF-1A44-A992-BCD6B75A67EA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190EEE-975F-B921-9469-EBBD4B7660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D673DC-6674-13E8-8C5C-41EA45114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1C749-EFBF-DB47-A9F3-5708168BD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33728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DC24F0-29EC-87A8-357E-771AAA504C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9849683-E6FE-EB89-4D6B-7F4F9E8401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A7EC31-803D-3924-0BAA-94F4244FD7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E2EDF-C2EF-1A44-A992-BCD6B75A67EA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4DCDDB-075D-B420-2FF5-5EAD4AA11B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9C0C9B-8100-79FC-751A-9B507FF247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1C749-EFBF-DB47-A9F3-5708168BD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654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920F395-2199-3738-FF82-76548839912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627C73B-ADA3-07E8-1632-0973CD6EBA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93E4012-EED1-0AD8-5A5B-31602BF6E6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E2EDF-C2EF-1A44-A992-BCD6B75A67EA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F2A5A28-E1C1-A215-0A02-09937CC286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2F0BED-D685-2F3C-569D-32653438E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1C749-EFBF-DB47-A9F3-5708168BD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60607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B32EFA-0341-6B8C-ACE3-D93CF2D598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7F22D9-E9EA-8748-EAA1-32D2C25421F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89B02C-E541-FAC9-4D04-60043E4258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E2EDF-C2EF-1A44-A992-BCD6B75A67EA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62462AD-FC32-578D-038C-33D6CF367F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840613-0D92-ED2E-0372-9A32B94808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1C749-EFBF-DB47-A9F3-5708168BD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2760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726B27-9040-7595-0080-B038C9EE7A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18C1497-9EC0-EF69-19C2-3FF6443E80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D53BCF-35BD-F668-23CC-7AFA8D48BA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E2EDF-C2EF-1A44-A992-BCD6B75A67EA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557263-FE1B-676E-55A2-A1AA227684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9F98E8-960B-D5A1-6055-7EC369B5E5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1C749-EFBF-DB47-A9F3-5708168BD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0982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04DF5B-8D87-D052-71FC-0FBC32AE8B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145A04-65E9-C144-F5AF-ACF22215A52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4088EC9-3684-17D0-5DAA-1C1EBC34199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7BBEA0A-4A6B-F193-4239-9E9CFB593A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E2EDF-C2EF-1A44-A992-BCD6B75A67EA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24CA8E2-CD46-D67B-4BDB-533AD63A2C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F4099E-2AD7-B13C-A1AF-37A5FD41BF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1C749-EFBF-DB47-A9F3-5708168BD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9498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296D85-F469-62E0-9EF7-C73F0D1AE3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14456C9-62DA-180B-7F42-2F77A395BC7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B7C334D-8B5A-2838-A2F4-67F44BF7F0E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8D53CA1-6827-9CEE-70D6-DC4B3B5A31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FDAE7A0-474D-FA11-EC03-AFEA4F55DFE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A1E71AC-69EE-4DC3-3F6A-E794B9D1EC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E2EDF-C2EF-1A44-A992-BCD6B75A67EA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BF25F6F-D4D0-E328-C0C4-80B3CB3E04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4741A89-E474-9770-9AFC-37A05C341A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1C749-EFBF-DB47-A9F3-5708168BD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33394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B8B11C-1167-7645-D8B6-230F1FF091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DAAF8E0-2276-0DE5-F770-624AA8B6CD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E2EDF-C2EF-1A44-A992-BCD6B75A67EA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EEA8D7A-7FD6-1E78-1FA8-C447FEF21B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693246A-836E-FA68-284F-EF460D2084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1C749-EFBF-DB47-A9F3-5708168BD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23935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4EDD49F-1C41-BB44-8FB6-2EEA640276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E2EDF-C2EF-1A44-A992-BCD6B75A67EA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189ECC7-B7C3-74A6-5A12-FAE0AD13E3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0C2948A-B67B-32E5-0535-024A16A46E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1C749-EFBF-DB47-A9F3-5708168BD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74830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2FA8FE-FBCB-43B7-111A-FB36C86CE8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5554296-7369-E884-E6A6-2315EC4720B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7BB00C8-9D34-5362-C12C-F868C2F3DE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8797911-B184-8858-CBFD-566B5A56E4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E2EDF-C2EF-1A44-A992-BCD6B75A67EA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0AD083-CE08-F2D3-E8BE-721FB8910F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98FC1E-1689-69A1-79B8-34AC747FC5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1C749-EFBF-DB47-A9F3-5708168BD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6840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5279D6-6443-31C0-CF1E-B7C0249E92C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E67555E-6723-0F32-1609-D3EE45C6E77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971367D-0074-79BD-30D9-1B162A5C953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377B1BB-1989-9C15-D050-EE4C509E8A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3E2EDF-C2EF-1A44-A992-BCD6B75A67EA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4EF231-C816-A731-62AA-BFE2D2A1A0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72B07FE-C0DE-90F7-300E-6BA727499B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1C749-EFBF-DB47-A9F3-5708168BD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2021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7DC5331-92D2-2ED3-2FE6-ED9547BA5F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753B2C7-1B8F-AAB8-3537-477CAD6804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C5F8A6-2752-DB90-B576-D04CF99FEF0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3E2EDF-C2EF-1A44-A992-BCD6B75A67EA}" type="datetimeFigureOut">
              <a:rPr lang="en-US" smtClean="0"/>
              <a:t>7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017F71-CE30-30A2-4FC7-49441F7A3AF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C6696A0-BA5E-AA93-99B1-A152FB53EE4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E1C749-EFBF-DB47-A9F3-5708168BD1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14700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jpeg"/><Relationship Id="rId3" Type="http://schemas.openxmlformats.org/officeDocument/2006/relationships/image" Target="../media/image4.jpeg"/><Relationship Id="rId7" Type="http://schemas.openxmlformats.org/officeDocument/2006/relationships/image" Target="../media/image8.jpeg"/><Relationship Id="rId12" Type="http://schemas.openxmlformats.org/officeDocument/2006/relationships/image" Target="../media/image13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11" Type="http://schemas.openxmlformats.org/officeDocument/2006/relationships/image" Target="../media/image12.jpeg"/><Relationship Id="rId5" Type="http://schemas.openxmlformats.org/officeDocument/2006/relationships/image" Target="../media/image6.png"/><Relationship Id="rId10" Type="http://schemas.openxmlformats.org/officeDocument/2006/relationships/image" Target="../media/image11.jpeg"/><Relationship Id="rId4" Type="http://schemas.openxmlformats.org/officeDocument/2006/relationships/image" Target="../media/image5.jpeg"/><Relationship Id="rId9" Type="http://schemas.openxmlformats.org/officeDocument/2006/relationships/image" Target="../media/image10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jpeg"/><Relationship Id="rId2" Type="http://schemas.openxmlformats.org/officeDocument/2006/relationships/image" Target="../media/image14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6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tif"/><Relationship Id="rId2" Type="http://schemas.openxmlformats.org/officeDocument/2006/relationships/image" Target="../media/image17.jp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9.ti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jpeg"/><Relationship Id="rId13" Type="http://schemas.openxmlformats.org/officeDocument/2006/relationships/image" Target="../media/image31.jpeg"/><Relationship Id="rId3" Type="http://schemas.openxmlformats.org/officeDocument/2006/relationships/image" Target="../media/image21.jpeg"/><Relationship Id="rId7" Type="http://schemas.openxmlformats.org/officeDocument/2006/relationships/image" Target="../media/image25.jpeg"/><Relationship Id="rId12" Type="http://schemas.openxmlformats.org/officeDocument/2006/relationships/image" Target="../media/image30.jpeg"/><Relationship Id="rId2" Type="http://schemas.openxmlformats.org/officeDocument/2006/relationships/image" Target="../media/image20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4.jpeg"/><Relationship Id="rId11" Type="http://schemas.openxmlformats.org/officeDocument/2006/relationships/image" Target="../media/image29.jpeg"/><Relationship Id="rId5" Type="http://schemas.openxmlformats.org/officeDocument/2006/relationships/image" Target="../media/image23.jpeg"/><Relationship Id="rId10" Type="http://schemas.openxmlformats.org/officeDocument/2006/relationships/image" Target="../media/image28.jpeg"/><Relationship Id="rId4" Type="http://schemas.openxmlformats.org/officeDocument/2006/relationships/image" Target="../media/image22.jpeg"/><Relationship Id="rId9" Type="http://schemas.openxmlformats.org/officeDocument/2006/relationships/image" Target="../media/image27.jpe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7" Type="http://schemas.openxmlformats.org/officeDocument/2006/relationships/image" Target="../media/image37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6.jpeg"/><Relationship Id="rId5" Type="http://schemas.openxmlformats.org/officeDocument/2006/relationships/image" Target="../media/image35.jpeg"/><Relationship Id="rId4" Type="http://schemas.openxmlformats.org/officeDocument/2006/relationships/image" Target="../media/image3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A picture containing wall, indoor, white&#10;&#10;Description generated with high confidence">
            <a:extLst>
              <a:ext uri="{FF2B5EF4-FFF2-40B4-BE49-F238E27FC236}">
                <a16:creationId xmlns:a16="http://schemas.microsoft.com/office/drawing/2014/main" id="{7333C39A-EBF1-8E79-F65F-5E5713DA6E7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018" t="24730" r="27591" b="30420"/>
          <a:stretch/>
        </p:blipFill>
        <p:spPr>
          <a:xfrm>
            <a:off x="554079" y="1148000"/>
            <a:ext cx="3019494" cy="2149995"/>
          </a:xfrm>
          <a:prstGeom prst="rect">
            <a:avLst/>
          </a:prstGeom>
          <a:ln>
            <a:noFill/>
          </a:ln>
        </p:spPr>
      </p:pic>
      <p:pic>
        <p:nvPicPr>
          <p:cNvPr id="3" name="Picture 2" descr="A close up of a logo&#10;&#10;Description generated with high confidence">
            <a:extLst>
              <a:ext uri="{FF2B5EF4-FFF2-40B4-BE49-F238E27FC236}">
                <a16:creationId xmlns:a16="http://schemas.microsoft.com/office/drawing/2014/main" id="{30048A41-DE12-8B1C-0DD4-5C23E371607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596" t="32936" r="27480" b="32169"/>
          <a:stretch/>
        </p:blipFill>
        <p:spPr>
          <a:xfrm>
            <a:off x="3798050" y="1148000"/>
            <a:ext cx="2991477" cy="1672670"/>
          </a:xfrm>
          <a:prstGeom prst="rect">
            <a:avLst/>
          </a:prstGeom>
          <a:ln>
            <a:noFill/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61A987E3-D9B1-EB90-A9A5-7B20720F5022}"/>
              </a:ext>
            </a:extLst>
          </p:cNvPr>
          <p:cNvSpPr txBox="1"/>
          <p:nvPr/>
        </p:nvSpPr>
        <p:spPr>
          <a:xfrm>
            <a:off x="286785" y="347414"/>
            <a:ext cx="334537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Figure 1B 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HA-Tag, BR1-3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A754EE7-DBDB-4E67-C9C9-EB969C89EF09}"/>
              </a:ext>
            </a:extLst>
          </p:cNvPr>
          <p:cNvSpPr txBox="1"/>
          <p:nvPr/>
        </p:nvSpPr>
        <p:spPr>
          <a:xfrm>
            <a:off x="3737692" y="344029"/>
            <a:ext cx="334537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Figure 1B </a:t>
            </a:r>
          </a:p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GAPDH, BR1-3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E4F1CF54-22A3-4EFA-B158-2B84DCEB712B}"/>
              </a:ext>
            </a:extLst>
          </p:cNvPr>
          <p:cNvSpPr txBox="1"/>
          <p:nvPr/>
        </p:nvSpPr>
        <p:spPr>
          <a:xfrm rot="18461822">
            <a:off x="1172993" y="904882"/>
            <a:ext cx="7472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NLS+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TERM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C9F10622-D1D9-8109-6B62-9EEFBD88C195}"/>
              </a:ext>
            </a:extLst>
          </p:cNvPr>
          <p:cNvSpPr txBox="1"/>
          <p:nvPr/>
        </p:nvSpPr>
        <p:spPr>
          <a:xfrm rot="18461822">
            <a:off x="449885" y="1024195"/>
            <a:ext cx="69772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SCV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5E9D8C4E-9520-B3F0-6574-5E8A27D1DA1B}"/>
              </a:ext>
            </a:extLst>
          </p:cNvPr>
          <p:cNvSpPr txBox="1"/>
          <p:nvPr/>
        </p:nvSpPr>
        <p:spPr>
          <a:xfrm rot="18461822">
            <a:off x="658935" y="1000184"/>
            <a:ext cx="7510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FLSEC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046033C-DCB7-0E0C-22E2-0D730950AF22}"/>
              </a:ext>
            </a:extLst>
          </p:cNvPr>
          <p:cNvSpPr txBox="1"/>
          <p:nvPr/>
        </p:nvSpPr>
        <p:spPr>
          <a:xfrm rot="18461822">
            <a:off x="903962" y="1035943"/>
            <a:ext cx="6680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NLS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E7F1339-1AE8-92A5-BB8A-022B8B3AF45E}"/>
              </a:ext>
            </a:extLst>
          </p:cNvPr>
          <p:cNvSpPr txBox="1"/>
          <p:nvPr/>
        </p:nvSpPr>
        <p:spPr>
          <a:xfrm rot="18461822">
            <a:off x="4411899" y="1465055"/>
            <a:ext cx="7472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NLS+</a:t>
            </a:r>
          </a:p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TERM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75A487CE-6C2D-FEEA-EE30-0BBA6580D3EC}"/>
              </a:ext>
            </a:extLst>
          </p:cNvPr>
          <p:cNvSpPr txBox="1"/>
          <p:nvPr/>
        </p:nvSpPr>
        <p:spPr>
          <a:xfrm rot="18461822">
            <a:off x="3688791" y="1584368"/>
            <a:ext cx="69772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MSCV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A7C059B0-B7BF-45D2-3411-B40A77F22CF1}"/>
              </a:ext>
            </a:extLst>
          </p:cNvPr>
          <p:cNvSpPr txBox="1"/>
          <p:nvPr/>
        </p:nvSpPr>
        <p:spPr>
          <a:xfrm rot="18461822">
            <a:off x="3897841" y="1560357"/>
            <a:ext cx="75107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FLSEC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175CBCE4-382F-2AE9-1D67-602B76692F6C}"/>
              </a:ext>
            </a:extLst>
          </p:cNvPr>
          <p:cNvSpPr txBox="1"/>
          <p:nvPr/>
        </p:nvSpPr>
        <p:spPr>
          <a:xfrm rot="18461822">
            <a:off x="4142868" y="1596116"/>
            <a:ext cx="66803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NLS</a:t>
            </a:r>
          </a:p>
        </p:txBody>
      </p:sp>
    </p:spTree>
    <p:extLst>
      <p:ext uri="{BB962C8B-B14F-4D97-AF65-F5344CB8AC3E}">
        <p14:creationId xmlns:p14="http://schemas.microsoft.com/office/powerpoint/2010/main" val="26957129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B6DC2D0-C9B3-8B27-76A7-6A03086964C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91" t="1730" r="22084" b="70214"/>
          <a:stretch/>
        </p:blipFill>
        <p:spPr>
          <a:xfrm>
            <a:off x="436099" y="459076"/>
            <a:ext cx="3348110" cy="1252024"/>
          </a:xfrm>
          <a:prstGeom prst="rect">
            <a:avLst/>
          </a:prstGeom>
          <a:ln>
            <a:noFill/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EE616AA-E064-6FCF-6F45-AFFCE377316B}"/>
              </a:ext>
            </a:extLst>
          </p:cNvPr>
          <p:cNvSpPr txBox="1"/>
          <p:nvPr/>
        </p:nvSpPr>
        <p:spPr>
          <a:xfrm>
            <a:off x="436099" y="157123"/>
            <a:ext cx="33453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Full unedited gel for Figure 4 (p27, BR1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6A3A1DA-8D31-959E-FDA1-49893A5E22B2}"/>
              </a:ext>
            </a:extLst>
          </p:cNvPr>
          <p:cNvSpPr txBox="1"/>
          <p:nvPr/>
        </p:nvSpPr>
        <p:spPr>
          <a:xfrm>
            <a:off x="3924885" y="180873"/>
            <a:ext cx="31343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Figure 4 (p27, BR2)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6197C3A3-CE66-8DA8-1C78-5C3D626A28B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952" t="51900" r="23032" b="19916"/>
          <a:stretch/>
        </p:blipFill>
        <p:spPr>
          <a:xfrm>
            <a:off x="7209303" y="459077"/>
            <a:ext cx="3260789" cy="1245810"/>
          </a:xfrm>
          <a:prstGeom prst="rect">
            <a:avLst/>
          </a:prstGeom>
          <a:ln>
            <a:noFill/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2266F2C7-EB11-BD83-E122-A35E13DE6C6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28" t="31943" r="24530" b="39681"/>
          <a:stretch/>
        </p:blipFill>
        <p:spPr>
          <a:xfrm>
            <a:off x="3922151" y="445008"/>
            <a:ext cx="3137095" cy="1266092"/>
          </a:xfrm>
          <a:prstGeom prst="rect">
            <a:avLst/>
          </a:prstGeom>
          <a:ln>
            <a:noFill/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A651EA8A-70F0-0E29-A262-ACFCAAB96A8E}"/>
              </a:ext>
            </a:extLst>
          </p:cNvPr>
          <p:cNvSpPr txBox="1"/>
          <p:nvPr/>
        </p:nvSpPr>
        <p:spPr>
          <a:xfrm>
            <a:off x="7223550" y="180873"/>
            <a:ext cx="326079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Figure 4 (p27, BR3)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8765ABAA-F5DD-8D2A-9F06-558FCE3197EE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9058" t="17916" r="31240" b="60845"/>
          <a:stretch/>
        </p:blipFill>
        <p:spPr>
          <a:xfrm>
            <a:off x="433365" y="2062677"/>
            <a:ext cx="3345376" cy="952108"/>
          </a:xfrm>
          <a:prstGeom prst="rect">
            <a:avLst/>
          </a:prstGeom>
          <a:ln>
            <a:noFill/>
          </a:ln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782D2559-1A65-714D-2B58-C075D88822D2}"/>
              </a:ext>
            </a:extLst>
          </p:cNvPr>
          <p:cNvSpPr txBox="1"/>
          <p:nvPr/>
        </p:nvSpPr>
        <p:spPr>
          <a:xfrm>
            <a:off x="433365" y="1760727"/>
            <a:ext cx="33453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Full unedited gel for Figure 4 (</a:t>
            </a:r>
            <a:r>
              <a:rPr lang="en-US" sz="1200" dirty="0" err="1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r>
              <a:rPr lang="en-US" sz="1200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, BR1)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81AADB6B-CD1A-7CF6-535A-FA04509ED5F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0494" t="34973" r="33408" b="44139"/>
          <a:stretch/>
        </p:blipFill>
        <p:spPr>
          <a:xfrm>
            <a:off x="3922151" y="2062677"/>
            <a:ext cx="3189996" cy="952108"/>
          </a:xfrm>
          <a:prstGeom prst="rect">
            <a:avLst/>
          </a:prstGeom>
          <a:ln>
            <a:noFill/>
          </a:ln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9F3499E1-32E1-9DF0-A707-F2A2DF2B81BA}"/>
              </a:ext>
            </a:extLst>
          </p:cNvPr>
          <p:cNvSpPr txBox="1"/>
          <p:nvPr/>
        </p:nvSpPr>
        <p:spPr>
          <a:xfrm>
            <a:off x="3924885" y="1760727"/>
            <a:ext cx="31872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Figure 4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BR2)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73C0E684-A688-707C-22ED-96CF64B306A7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8489" t="46073" r="33845" b="32339"/>
          <a:stretch/>
        </p:blipFill>
        <p:spPr>
          <a:xfrm>
            <a:off x="7229274" y="2060258"/>
            <a:ext cx="3187262" cy="954527"/>
          </a:xfrm>
          <a:prstGeom prst="rect">
            <a:avLst/>
          </a:prstGeom>
          <a:ln>
            <a:noFill/>
          </a:ln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38C0C61D-BEF0-4C19-FF31-30953BBC2911}"/>
              </a:ext>
            </a:extLst>
          </p:cNvPr>
          <p:cNvSpPr txBox="1"/>
          <p:nvPr/>
        </p:nvSpPr>
        <p:spPr>
          <a:xfrm>
            <a:off x="7249246" y="1774794"/>
            <a:ext cx="31872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Figure 4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BR3)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0EF3CAE2-3325-B4F1-B8A8-BA57A3C01D20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7908" t="17823" r="24231" b="64617"/>
          <a:stretch/>
        </p:blipFill>
        <p:spPr>
          <a:xfrm>
            <a:off x="427897" y="3338905"/>
            <a:ext cx="3345376" cy="812104"/>
          </a:xfrm>
          <a:prstGeom prst="rect">
            <a:avLst/>
          </a:prstGeom>
          <a:ln>
            <a:noFill/>
          </a:ln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6F72B006-ADF0-4510-95F7-C74D75E1AA1A}"/>
              </a:ext>
            </a:extLst>
          </p:cNvPr>
          <p:cNvSpPr txBox="1"/>
          <p:nvPr/>
        </p:nvSpPr>
        <p:spPr>
          <a:xfrm>
            <a:off x="427897" y="3066753"/>
            <a:ext cx="33453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Full unedited gel for Figure 4 (ERK, BR1)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1C9111D2-FAA5-6492-0A49-18184CAD480F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19822" t="34900" r="22614" b="46637"/>
          <a:stretch/>
        </p:blipFill>
        <p:spPr>
          <a:xfrm>
            <a:off x="3934121" y="3338905"/>
            <a:ext cx="3189996" cy="818611"/>
          </a:xfrm>
          <a:prstGeom prst="rect">
            <a:avLst/>
          </a:prstGeom>
          <a:ln>
            <a:noFill/>
          </a:ln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3C395FAD-10FB-9C90-0BDE-AEBF76645AF4}"/>
              </a:ext>
            </a:extLst>
          </p:cNvPr>
          <p:cNvSpPr txBox="1"/>
          <p:nvPr/>
        </p:nvSpPr>
        <p:spPr>
          <a:xfrm>
            <a:off x="3713870" y="3066752"/>
            <a:ext cx="33453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Figure 4 (ERK, BR2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1312585-A36F-D3CB-251F-95DF7521E1E5}"/>
              </a:ext>
            </a:extLst>
          </p:cNvPr>
          <p:cNvSpPr txBox="1"/>
          <p:nvPr/>
        </p:nvSpPr>
        <p:spPr>
          <a:xfrm>
            <a:off x="7249246" y="3079782"/>
            <a:ext cx="33453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Figure 4 (ERK, BR2)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FDB2EDC2-6D0B-8F32-24E6-C2D708F9D563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0593" t="48894" r="24581" b="32844"/>
          <a:stretch/>
        </p:blipFill>
        <p:spPr>
          <a:xfrm>
            <a:off x="7279497" y="3338905"/>
            <a:ext cx="3227205" cy="860022"/>
          </a:xfrm>
          <a:prstGeom prst="rect">
            <a:avLst/>
          </a:prstGeom>
          <a:ln>
            <a:noFill/>
          </a:ln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321FCA58-0EBF-D274-441A-175D70806BD9}"/>
              </a:ext>
            </a:extLst>
          </p:cNvPr>
          <p:cNvSpPr txBox="1"/>
          <p:nvPr/>
        </p:nvSpPr>
        <p:spPr>
          <a:xfrm>
            <a:off x="368494" y="4207557"/>
            <a:ext cx="3345376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Full unedited gel for Figure 4 (p-p38, BR1)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3E7F1F1B-8970-4C62-F70B-7C29F78F1CAF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213" t="16013" r="30359" b="66042"/>
          <a:stretch/>
        </p:blipFill>
        <p:spPr>
          <a:xfrm>
            <a:off x="427897" y="4477410"/>
            <a:ext cx="3353578" cy="918251"/>
          </a:xfrm>
          <a:prstGeom prst="rect">
            <a:avLst/>
          </a:prstGeom>
          <a:ln>
            <a:noFill/>
          </a:ln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22DACEE9-01B0-74DC-7BBF-6E842CEFE813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416" t="32756" r="30983" b="51647"/>
          <a:stretch/>
        </p:blipFill>
        <p:spPr>
          <a:xfrm>
            <a:off x="3890321" y="4505386"/>
            <a:ext cx="3189996" cy="819049"/>
          </a:xfrm>
          <a:prstGeom prst="rect">
            <a:avLst/>
          </a:prstGeom>
          <a:ln>
            <a:noFill/>
          </a:ln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6701CE0B-E1A9-A139-F9E8-E156E12695B8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92" t="52329" r="30541" b="32039"/>
          <a:stretch/>
        </p:blipFill>
        <p:spPr>
          <a:xfrm>
            <a:off x="7279497" y="4505385"/>
            <a:ext cx="3187264" cy="819049"/>
          </a:xfrm>
          <a:prstGeom prst="rect">
            <a:avLst/>
          </a:prstGeom>
          <a:ln>
            <a:noFill/>
          </a:ln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A00EDDB9-3712-1B50-4FE5-B53EA61782AA}"/>
              </a:ext>
            </a:extLst>
          </p:cNvPr>
          <p:cNvSpPr txBox="1"/>
          <p:nvPr/>
        </p:nvSpPr>
        <p:spPr>
          <a:xfrm>
            <a:off x="3903870" y="4207557"/>
            <a:ext cx="3345376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Figure 4 (p-p38, BR2)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B04CD2DD-8092-BA6B-92E7-20D52A334FB2}"/>
              </a:ext>
            </a:extLst>
          </p:cNvPr>
          <p:cNvSpPr txBox="1"/>
          <p:nvPr/>
        </p:nvSpPr>
        <p:spPr>
          <a:xfrm>
            <a:off x="7316706" y="4207557"/>
            <a:ext cx="3345376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Figure 4 (p-p38, BR3)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6AB8B4DA-97E7-D869-523A-A5AD13141F3C}"/>
              </a:ext>
            </a:extLst>
          </p:cNvPr>
          <p:cNvSpPr txBox="1"/>
          <p:nvPr/>
        </p:nvSpPr>
        <p:spPr>
          <a:xfrm>
            <a:off x="368494" y="5394342"/>
            <a:ext cx="3345376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Full unedited gel for Figure 4 (p38, BR1)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7A82CC3D-FDD8-7E2E-EE4D-8904DFAD4FAB}"/>
              </a:ext>
            </a:extLst>
          </p:cNvPr>
          <p:cNvSpPr txBox="1"/>
          <p:nvPr/>
        </p:nvSpPr>
        <p:spPr>
          <a:xfrm>
            <a:off x="3903870" y="5394342"/>
            <a:ext cx="3345376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Figure 4 (p38, BR2)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4AF179B-8906-10D7-2EAF-D69B9C0A8AFD}"/>
              </a:ext>
            </a:extLst>
          </p:cNvPr>
          <p:cNvSpPr txBox="1"/>
          <p:nvPr/>
        </p:nvSpPr>
        <p:spPr>
          <a:xfrm>
            <a:off x="7316706" y="5394342"/>
            <a:ext cx="3345376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Figure 4 (p38, BR3)</a:t>
            </a:r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A042D3F0-0B40-9E1D-B653-4410714214CF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844" t="16947" r="25215" b="67578"/>
          <a:stretch/>
        </p:blipFill>
        <p:spPr>
          <a:xfrm>
            <a:off x="427897" y="5722062"/>
            <a:ext cx="3277770" cy="781184"/>
          </a:xfrm>
          <a:prstGeom prst="rect">
            <a:avLst/>
          </a:prstGeom>
          <a:ln>
            <a:noFill/>
          </a:ln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CF947537-D8C9-3882-95F0-2FD73E4BB9EE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828" t="36260" r="26762" b="48720"/>
          <a:stretch/>
        </p:blipFill>
        <p:spPr>
          <a:xfrm>
            <a:off x="7350509" y="5702120"/>
            <a:ext cx="3277770" cy="781184"/>
          </a:xfrm>
          <a:prstGeom prst="rect">
            <a:avLst/>
          </a:prstGeom>
          <a:ln>
            <a:noFill/>
          </a:ln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35270324-BB72-0548-E529-842E7F79D407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539" t="57422" r="26678" b="27448"/>
          <a:stretch/>
        </p:blipFill>
        <p:spPr>
          <a:xfrm>
            <a:off x="3903870" y="5722062"/>
            <a:ext cx="3277770" cy="781184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75293238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730AD33-92E4-0829-E637-68B9F47D282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116" t="12066" r="24692" b="69565"/>
          <a:stretch/>
        </p:blipFill>
        <p:spPr>
          <a:xfrm>
            <a:off x="317346" y="518725"/>
            <a:ext cx="3016331" cy="819650"/>
          </a:xfrm>
          <a:prstGeom prst="rect">
            <a:avLst/>
          </a:prstGeom>
          <a:ln>
            <a:noFill/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EAAF378-F965-1F21-C76C-AD2AFE94F3AD}"/>
              </a:ext>
            </a:extLst>
          </p:cNvPr>
          <p:cNvSpPr txBox="1"/>
          <p:nvPr/>
        </p:nvSpPr>
        <p:spPr>
          <a:xfrm>
            <a:off x="223958" y="257762"/>
            <a:ext cx="33453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Full unedited gel for Figure 4 (Tubulin, BR1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89E0F18-3DB6-A364-A08E-3FEDEE76F9A6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40" t="32350" r="22559" b="49385"/>
          <a:stretch/>
        </p:blipFill>
        <p:spPr>
          <a:xfrm>
            <a:off x="3768002" y="522040"/>
            <a:ext cx="3260788" cy="818610"/>
          </a:xfrm>
          <a:prstGeom prst="rect">
            <a:avLst/>
          </a:prstGeom>
          <a:ln>
            <a:noFill/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FD79A58-7A9F-A10B-AA1D-CFA2AF3C067B}"/>
              </a:ext>
            </a:extLst>
          </p:cNvPr>
          <p:cNvSpPr txBox="1"/>
          <p:nvPr/>
        </p:nvSpPr>
        <p:spPr>
          <a:xfrm>
            <a:off x="3699257" y="257761"/>
            <a:ext cx="33453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Figure 4 (Tubulin, BR2)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AB768C94-6E21-32FB-C43E-91545F04EA20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349" t="55998" r="21475" b="26057"/>
          <a:stretch/>
        </p:blipFill>
        <p:spPr>
          <a:xfrm>
            <a:off x="7227458" y="518725"/>
            <a:ext cx="3260787" cy="818610"/>
          </a:xfrm>
          <a:prstGeom prst="rect">
            <a:avLst/>
          </a:prstGeom>
          <a:ln>
            <a:noFill/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F5D99A78-9E02-8786-CFDF-795C6981AC0D}"/>
              </a:ext>
            </a:extLst>
          </p:cNvPr>
          <p:cNvSpPr txBox="1"/>
          <p:nvPr/>
        </p:nvSpPr>
        <p:spPr>
          <a:xfrm>
            <a:off x="7185163" y="257760"/>
            <a:ext cx="33453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Figure 4 (Tubulin, BR3)</a:t>
            </a:r>
          </a:p>
        </p:txBody>
      </p:sp>
    </p:spTree>
    <p:extLst>
      <p:ext uri="{BB962C8B-B14F-4D97-AF65-F5344CB8AC3E}">
        <p14:creationId xmlns:p14="http://schemas.microsoft.com/office/powerpoint/2010/main" val="102602037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1C8D4BE-A66A-9B81-8241-164DEEF49BE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83" t="-5248" r="-805" b="-3143"/>
          <a:stretch/>
        </p:blipFill>
        <p:spPr>
          <a:xfrm>
            <a:off x="318295" y="804870"/>
            <a:ext cx="3161175" cy="2470192"/>
          </a:xfrm>
          <a:prstGeom prst="rect">
            <a:avLst/>
          </a:prstGeom>
          <a:ln w="12700">
            <a:noFill/>
          </a:ln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8C24FD9-35F9-16E8-4EA1-9BF00D442D03}"/>
              </a:ext>
            </a:extLst>
          </p:cNvPr>
          <p:cNvSpPr txBox="1"/>
          <p:nvPr/>
        </p:nvSpPr>
        <p:spPr>
          <a:xfrm>
            <a:off x="226194" y="437271"/>
            <a:ext cx="33453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 (Ha-Tag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FF20BE9-39AF-D091-5D3E-F38386669A22}"/>
              </a:ext>
            </a:extLst>
          </p:cNvPr>
          <p:cNvSpPr txBox="1"/>
          <p:nvPr/>
        </p:nvSpPr>
        <p:spPr>
          <a:xfrm>
            <a:off x="3353952" y="437271"/>
            <a:ext cx="33453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 (GAPDH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B89F995-B852-51F3-4798-54A333987928}"/>
              </a:ext>
            </a:extLst>
          </p:cNvPr>
          <p:cNvSpPr txBox="1"/>
          <p:nvPr/>
        </p:nvSpPr>
        <p:spPr>
          <a:xfrm>
            <a:off x="6551888" y="437271"/>
            <a:ext cx="33453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 (HDAC2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79EDF4C4-DE4D-25DD-6A50-5683CDADB18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587" t="24766" r="25539" b="34730"/>
          <a:stretch/>
        </p:blipFill>
        <p:spPr>
          <a:xfrm>
            <a:off x="3648124" y="901692"/>
            <a:ext cx="2954289" cy="1810512"/>
          </a:xfrm>
          <a:prstGeom prst="rect">
            <a:avLst/>
          </a:prstGeom>
          <a:ln>
            <a:noFill/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DE207F63-5EEC-7563-BD76-2AE12181264F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044" t="22565" r="23992" b="36862"/>
          <a:stretch/>
        </p:blipFill>
        <p:spPr>
          <a:xfrm>
            <a:off x="6798368" y="901692"/>
            <a:ext cx="2954289" cy="1810512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16259580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106A4C5-6AF0-EEC4-32C5-26D930C98834}"/>
              </a:ext>
            </a:extLst>
          </p:cNvPr>
          <p:cNvSpPr txBox="1"/>
          <p:nvPr/>
        </p:nvSpPr>
        <p:spPr>
          <a:xfrm>
            <a:off x="436099" y="118750"/>
            <a:ext cx="33453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A-B (p27, BR1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0022B15-C679-EDDC-B5F5-518BCA4000D3}"/>
              </a:ext>
            </a:extLst>
          </p:cNvPr>
          <p:cNvSpPr txBox="1"/>
          <p:nvPr/>
        </p:nvSpPr>
        <p:spPr>
          <a:xfrm>
            <a:off x="4222348" y="118750"/>
            <a:ext cx="33453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A-B (p27, BR2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EAEACC0-953B-4B55-846A-C3BB0478B02A}"/>
              </a:ext>
            </a:extLst>
          </p:cNvPr>
          <p:cNvSpPr txBox="1"/>
          <p:nvPr/>
        </p:nvSpPr>
        <p:spPr>
          <a:xfrm>
            <a:off x="8008597" y="83125"/>
            <a:ext cx="33453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Full unedited gel for </a:t>
            </a:r>
          </a:p>
          <a:p>
            <a:pPr algn="ctr"/>
            <a:r>
              <a:rPr lang="en-US" sz="1200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Supplementary Figure 4A-B (p27, BR3)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39A874DD-00DE-CE11-D759-FC658E0417D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92" t="7522" r="26454" b="76245"/>
          <a:stretch/>
        </p:blipFill>
        <p:spPr>
          <a:xfrm>
            <a:off x="564995" y="604463"/>
            <a:ext cx="3087583" cy="724395"/>
          </a:xfrm>
          <a:prstGeom prst="rect">
            <a:avLst/>
          </a:prstGeom>
          <a:ln>
            <a:noFill/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7D3367F1-BA76-0E0F-FC65-CE5C62678D55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52" t="29596" r="26891" b="54551"/>
          <a:stretch/>
        </p:blipFill>
        <p:spPr>
          <a:xfrm>
            <a:off x="4351245" y="604463"/>
            <a:ext cx="3087582" cy="724395"/>
          </a:xfrm>
          <a:prstGeom prst="rect">
            <a:avLst/>
          </a:prstGeom>
          <a:ln>
            <a:noFill/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2CA8A82C-10FF-54DA-2E6B-B3EA53C8FA6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06" t="48160" r="27495" b="35607"/>
          <a:stretch/>
        </p:blipFill>
        <p:spPr>
          <a:xfrm>
            <a:off x="8008597" y="604463"/>
            <a:ext cx="3140352" cy="724394"/>
          </a:xfrm>
          <a:prstGeom prst="rect">
            <a:avLst/>
          </a:prstGeom>
          <a:ln>
            <a:noFill/>
          </a:ln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047A2521-E0C2-75FC-F44A-8C174E801C1B}"/>
              </a:ext>
            </a:extLst>
          </p:cNvPr>
          <p:cNvSpPr txBox="1"/>
          <p:nvPr/>
        </p:nvSpPr>
        <p:spPr>
          <a:xfrm>
            <a:off x="436099" y="1435732"/>
            <a:ext cx="33453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A-B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BR1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DFB525B-5571-738E-D904-83072906E137}"/>
              </a:ext>
            </a:extLst>
          </p:cNvPr>
          <p:cNvSpPr txBox="1"/>
          <p:nvPr/>
        </p:nvSpPr>
        <p:spPr>
          <a:xfrm>
            <a:off x="4222348" y="1435732"/>
            <a:ext cx="33453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A-B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BR2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D0E1738F-3102-A093-CA4D-B50F2E035388}"/>
              </a:ext>
            </a:extLst>
          </p:cNvPr>
          <p:cNvSpPr txBox="1"/>
          <p:nvPr/>
        </p:nvSpPr>
        <p:spPr>
          <a:xfrm>
            <a:off x="8008597" y="1400107"/>
            <a:ext cx="33453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Full unedited gel for </a:t>
            </a:r>
          </a:p>
          <a:p>
            <a:pPr algn="ctr"/>
            <a:r>
              <a:rPr lang="en-US" sz="1200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Supplementary Figure 4A-B (</a:t>
            </a:r>
            <a:r>
              <a:rPr lang="en-US" sz="1200" dirty="0" err="1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r>
              <a:rPr lang="en-US" sz="1200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, BR3)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F7E9DF74-5659-F621-2DE3-51715010FDEF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686" t="19722" r="23463" b="62932"/>
          <a:stretch/>
        </p:blipFill>
        <p:spPr>
          <a:xfrm>
            <a:off x="564996" y="1958952"/>
            <a:ext cx="3087582" cy="795646"/>
          </a:xfrm>
          <a:prstGeom prst="rect">
            <a:avLst/>
          </a:prstGeom>
          <a:ln>
            <a:noFill/>
          </a:ln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8225B409-4874-9625-DDED-10A4ED8AF0B9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16" t="46312" r="23718" b="36335"/>
          <a:stretch/>
        </p:blipFill>
        <p:spPr>
          <a:xfrm>
            <a:off x="4351245" y="1957069"/>
            <a:ext cx="3087582" cy="795645"/>
          </a:xfrm>
          <a:prstGeom prst="rect">
            <a:avLst/>
          </a:prstGeom>
          <a:ln>
            <a:noFill/>
          </a:ln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80125889-B128-1D03-7269-84095ADE6238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33" t="76689" r="23666" b="5917"/>
          <a:stretch/>
        </p:blipFill>
        <p:spPr>
          <a:xfrm>
            <a:off x="8008597" y="1957069"/>
            <a:ext cx="3087581" cy="795645"/>
          </a:xfrm>
          <a:prstGeom prst="rect">
            <a:avLst/>
          </a:prstGeom>
          <a:ln>
            <a:noFill/>
          </a:ln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5F16163D-93BA-19A7-CB6A-E12821272929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34" t="10434" r="22601" b="65814"/>
          <a:stretch/>
        </p:blipFill>
        <p:spPr>
          <a:xfrm>
            <a:off x="564995" y="3262746"/>
            <a:ext cx="3216478" cy="1059964"/>
          </a:xfrm>
          <a:prstGeom prst="rect">
            <a:avLst/>
          </a:prstGeom>
          <a:ln>
            <a:noFill/>
          </a:ln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1CD5CB03-DC87-094F-82B1-2EB929954FEE}"/>
              </a:ext>
            </a:extLst>
          </p:cNvPr>
          <p:cNvSpPr txBox="1"/>
          <p:nvPr/>
        </p:nvSpPr>
        <p:spPr>
          <a:xfrm>
            <a:off x="436097" y="2786456"/>
            <a:ext cx="33453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A-B (ERK, BR1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FBB57D49-F837-C25E-8FD2-955D52B19F1A}"/>
              </a:ext>
            </a:extLst>
          </p:cNvPr>
          <p:cNvSpPr txBox="1"/>
          <p:nvPr/>
        </p:nvSpPr>
        <p:spPr>
          <a:xfrm>
            <a:off x="4222346" y="2786456"/>
            <a:ext cx="33453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A-B (ERK, BR2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555675E-C3CE-C661-84C2-3CB304AF93C1}"/>
              </a:ext>
            </a:extLst>
          </p:cNvPr>
          <p:cNvSpPr txBox="1"/>
          <p:nvPr/>
        </p:nvSpPr>
        <p:spPr>
          <a:xfrm>
            <a:off x="8008595" y="2750831"/>
            <a:ext cx="33453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Full unedited gel for </a:t>
            </a:r>
          </a:p>
          <a:p>
            <a:pPr algn="ctr"/>
            <a:r>
              <a:rPr lang="en-US" sz="1200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Supplementary Figure 4A-B (ERK, BR3)</a:t>
            </a: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11CCAF07-D262-D02F-309F-43F7114DF308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50" t="37128" r="23070" b="39647"/>
          <a:stretch/>
        </p:blipFill>
        <p:spPr>
          <a:xfrm>
            <a:off x="4222346" y="3262746"/>
            <a:ext cx="3216477" cy="1059964"/>
          </a:xfrm>
          <a:prstGeom prst="rect">
            <a:avLst/>
          </a:prstGeom>
          <a:ln>
            <a:noFill/>
          </a:ln>
        </p:spPr>
      </p:pic>
      <p:pic>
        <p:nvPicPr>
          <p:cNvPr id="23" name="Picture 22">
            <a:extLst>
              <a:ext uri="{FF2B5EF4-FFF2-40B4-BE49-F238E27FC236}">
                <a16:creationId xmlns:a16="http://schemas.microsoft.com/office/drawing/2014/main" id="{0EF0E015-CE10-4CE7-A118-7FF8BE767F2B}"/>
              </a:ext>
            </a:extLst>
          </p:cNvPr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356" t="63380" r="26585" b="12706"/>
          <a:stretch/>
        </p:blipFill>
        <p:spPr>
          <a:xfrm>
            <a:off x="8008591" y="3262746"/>
            <a:ext cx="3216477" cy="1059964"/>
          </a:xfrm>
          <a:prstGeom prst="rect">
            <a:avLst/>
          </a:prstGeom>
          <a:ln>
            <a:noFill/>
          </a:ln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0E5E10FD-6CAF-5D37-D97C-445CD60EBFDF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780" t="15931" r="27001" b="65020"/>
          <a:stretch/>
        </p:blipFill>
        <p:spPr>
          <a:xfrm>
            <a:off x="564995" y="4853685"/>
            <a:ext cx="3216477" cy="878681"/>
          </a:xfrm>
          <a:prstGeom prst="rect">
            <a:avLst/>
          </a:prstGeom>
          <a:ln>
            <a:noFill/>
          </a:ln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B0F9B634-0B0D-A455-5E93-51A80281405E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388" t="43726" r="27568" b="37134"/>
          <a:stretch/>
        </p:blipFill>
        <p:spPr>
          <a:xfrm>
            <a:off x="4222347" y="4851618"/>
            <a:ext cx="3216476" cy="878681"/>
          </a:xfrm>
          <a:prstGeom prst="rect">
            <a:avLst/>
          </a:prstGeom>
          <a:ln>
            <a:noFill/>
          </a:ln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93EB0801-F9FD-34C4-900C-54E20238A0B8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441" t="75291" r="25993" b="5558"/>
          <a:stretch/>
        </p:blipFill>
        <p:spPr>
          <a:xfrm>
            <a:off x="7879698" y="4851617"/>
            <a:ext cx="3474273" cy="878681"/>
          </a:xfrm>
          <a:prstGeom prst="rect">
            <a:avLst/>
          </a:prstGeom>
          <a:ln>
            <a:noFill/>
          </a:ln>
        </p:spPr>
      </p:pic>
      <p:sp>
        <p:nvSpPr>
          <p:cNvPr id="27" name="TextBox 26">
            <a:extLst>
              <a:ext uri="{FF2B5EF4-FFF2-40B4-BE49-F238E27FC236}">
                <a16:creationId xmlns:a16="http://schemas.microsoft.com/office/drawing/2014/main" id="{DCA0381E-3538-F0A8-2AEE-E171EA78E60B}"/>
              </a:ext>
            </a:extLst>
          </p:cNvPr>
          <p:cNvSpPr txBox="1"/>
          <p:nvPr/>
        </p:nvSpPr>
        <p:spPr>
          <a:xfrm>
            <a:off x="436097" y="4352736"/>
            <a:ext cx="33453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A-B (Tubulin, BR1)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1402914-72B7-F7E9-9EBD-DE1DB3FF026B}"/>
              </a:ext>
            </a:extLst>
          </p:cNvPr>
          <p:cNvSpPr txBox="1"/>
          <p:nvPr/>
        </p:nvSpPr>
        <p:spPr>
          <a:xfrm>
            <a:off x="4222346" y="4352736"/>
            <a:ext cx="33453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A-B (Tubulin, BR2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9B4843B-D45D-5E37-7660-6266AFF79375}"/>
              </a:ext>
            </a:extLst>
          </p:cNvPr>
          <p:cNvSpPr txBox="1"/>
          <p:nvPr/>
        </p:nvSpPr>
        <p:spPr>
          <a:xfrm>
            <a:off x="8008595" y="4317111"/>
            <a:ext cx="33453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Full unedited gel for </a:t>
            </a:r>
          </a:p>
          <a:p>
            <a:pPr algn="ctr"/>
            <a:r>
              <a:rPr lang="en-US" sz="1200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Supplementary Figure 4A-B (Tubulin, BR3)</a:t>
            </a:r>
          </a:p>
        </p:txBody>
      </p:sp>
    </p:spTree>
    <p:extLst>
      <p:ext uri="{BB962C8B-B14F-4D97-AF65-F5344CB8AC3E}">
        <p14:creationId xmlns:p14="http://schemas.microsoft.com/office/powerpoint/2010/main" val="31279963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E74BDA3-17F3-65CF-0847-C96A15519273}"/>
              </a:ext>
            </a:extLst>
          </p:cNvPr>
          <p:cNvSpPr txBox="1"/>
          <p:nvPr/>
        </p:nvSpPr>
        <p:spPr>
          <a:xfrm>
            <a:off x="436099" y="106876"/>
            <a:ext cx="3345376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Full unedited gel for </a:t>
            </a:r>
          </a:p>
          <a:p>
            <a:pPr algn="ctr"/>
            <a:r>
              <a:rPr lang="en-US" sz="1200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Supplementary Figure 4C-D (p27, BR1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AAAEAA7-446B-6210-39C5-F196E8667216}"/>
              </a:ext>
            </a:extLst>
          </p:cNvPr>
          <p:cNvSpPr txBox="1"/>
          <p:nvPr/>
        </p:nvSpPr>
        <p:spPr>
          <a:xfrm>
            <a:off x="4115472" y="106876"/>
            <a:ext cx="3345376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C-D (p27, BR2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4192095-71D6-27D5-E83F-D73F39477CC0}"/>
              </a:ext>
            </a:extLst>
          </p:cNvPr>
          <p:cNvSpPr txBox="1"/>
          <p:nvPr/>
        </p:nvSpPr>
        <p:spPr>
          <a:xfrm>
            <a:off x="8008597" y="71251"/>
            <a:ext cx="3345376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C-D (p27, BR3)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24E0E338-8207-CCF7-BF85-A331F143637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866" t="8999" r="28814" b="67266"/>
          <a:stretch/>
        </p:blipFill>
        <p:spPr>
          <a:xfrm>
            <a:off x="436099" y="630096"/>
            <a:ext cx="3345376" cy="1068778"/>
          </a:xfrm>
          <a:prstGeom prst="rect">
            <a:avLst/>
          </a:prstGeom>
          <a:ln>
            <a:noFill/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2EA45B4C-B4E5-0144-EDED-1648170592E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3764" t="32702" r="30276" b="44949"/>
          <a:stretch/>
        </p:blipFill>
        <p:spPr>
          <a:xfrm>
            <a:off x="4115472" y="630096"/>
            <a:ext cx="3345376" cy="1068778"/>
          </a:xfrm>
          <a:prstGeom prst="rect">
            <a:avLst/>
          </a:prstGeom>
          <a:ln>
            <a:noFill/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686BBB91-E8C9-5787-2835-9F045D06718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1923" t="54435" r="28346" b="23312"/>
          <a:stretch/>
        </p:blipFill>
        <p:spPr>
          <a:xfrm>
            <a:off x="7767807" y="630096"/>
            <a:ext cx="3586166" cy="1068778"/>
          </a:xfrm>
          <a:prstGeom prst="rect">
            <a:avLst/>
          </a:prstGeom>
          <a:ln>
            <a:noFill/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6D38349E-B1EE-91BD-DBB6-ECB8BC36FAE9}"/>
              </a:ext>
            </a:extLst>
          </p:cNvPr>
          <p:cNvSpPr txBox="1"/>
          <p:nvPr/>
        </p:nvSpPr>
        <p:spPr>
          <a:xfrm>
            <a:off x="436099" y="1734499"/>
            <a:ext cx="3345376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Full unedited gel for </a:t>
            </a:r>
          </a:p>
          <a:p>
            <a:pPr algn="ctr"/>
            <a:r>
              <a:rPr lang="en-US" sz="1200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Supplementary Figure 4C-D (</a:t>
            </a:r>
            <a:r>
              <a:rPr lang="en-US" sz="1200" dirty="0" err="1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r>
              <a:rPr lang="en-US" sz="1200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, BR1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77A4D9D-E94F-C60C-CE52-96A1E8DCFAA5}"/>
              </a:ext>
            </a:extLst>
          </p:cNvPr>
          <p:cNvSpPr txBox="1"/>
          <p:nvPr/>
        </p:nvSpPr>
        <p:spPr>
          <a:xfrm>
            <a:off x="4115472" y="1734499"/>
            <a:ext cx="3345376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C-D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BR2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F1B7EF0-156E-27C8-6817-B4F1FD0C1486}"/>
              </a:ext>
            </a:extLst>
          </p:cNvPr>
          <p:cNvSpPr txBox="1"/>
          <p:nvPr/>
        </p:nvSpPr>
        <p:spPr>
          <a:xfrm>
            <a:off x="8008597" y="1698874"/>
            <a:ext cx="3345376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C-D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ERK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, BR3)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BF9DA6A1-309B-0367-8EB4-25E783AF596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9353" t="18211" r="23946" b="62011"/>
          <a:stretch/>
        </p:blipFill>
        <p:spPr>
          <a:xfrm>
            <a:off x="457323" y="2280065"/>
            <a:ext cx="3319559" cy="926276"/>
          </a:xfrm>
          <a:prstGeom prst="rect">
            <a:avLst/>
          </a:prstGeom>
          <a:ln>
            <a:noFill/>
          </a:ln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39178F24-0E37-594B-D663-39EFCAD9B4C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0181" t="45660" r="24957" b="35353"/>
          <a:stretch/>
        </p:blipFill>
        <p:spPr>
          <a:xfrm>
            <a:off x="4115472" y="2280065"/>
            <a:ext cx="3345376" cy="926276"/>
          </a:xfrm>
          <a:prstGeom prst="rect">
            <a:avLst/>
          </a:prstGeom>
          <a:ln>
            <a:noFill/>
          </a:ln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A6FFC172-0083-E1EF-6B73-28878123E96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6728" t="69676" r="23636" b="10606"/>
          <a:stretch/>
        </p:blipFill>
        <p:spPr>
          <a:xfrm>
            <a:off x="7767807" y="2257720"/>
            <a:ext cx="3586166" cy="948621"/>
          </a:xfrm>
          <a:prstGeom prst="rect">
            <a:avLst/>
          </a:prstGeom>
          <a:ln>
            <a:noFill/>
          </a:ln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21DFEF45-4301-5E37-64FF-57F98DA86380}"/>
              </a:ext>
            </a:extLst>
          </p:cNvPr>
          <p:cNvSpPr txBox="1"/>
          <p:nvPr/>
        </p:nvSpPr>
        <p:spPr>
          <a:xfrm>
            <a:off x="457323" y="3290872"/>
            <a:ext cx="3345376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Full unedited gel for </a:t>
            </a:r>
          </a:p>
          <a:p>
            <a:pPr algn="ctr"/>
            <a:r>
              <a:rPr lang="en-US" sz="1200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Supplementary Figure 4C-D (ERK, BR1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32053298-87CA-299E-4452-07B6316F276F}"/>
              </a:ext>
            </a:extLst>
          </p:cNvPr>
          <p:cNvSpPr txBox="1"/>
          <p:nvPr/>
        </p:nvSpPr>
        <p:spPr>
          <a:xfrm>
            <a:off x="4136696" y="3290872"/>
            <a:ext cx="3345376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C-D (ERK, BR2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6CB79F7-F659-A5D0-4DD3-105C9F79F5FF}"/>
              </a:ext>
            </a:extLst>
          </p:cNvPr>
          <p:cNvSpPr txBox="1"/>
          <p:nvPr/>
        </p:nvSpPr>
        <p:spPr>
          <a:xfrm>
            <a:off x="8029821" y="3255247"/>
            <a:ext cx="3345376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C-D (ERK, BR3)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282EE4E2-6A86-A702-BAB5-69E8E202A4FB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11" t="15641" r="34978" b="60875"/>
          <a:stretch/>
        </p:blipFill>
        <p:spPr>
          <a:xfrm>
            <a:off x="431506" y="3778468"/>
            <a:ext cx="3345376" cy="1068777"/>
          </a:xfrm>
          <a:prstGeom prst="rect">
            <a:avLst/>
          </a:prstGeom>
          <a:ln>
            <a:noFill/>
          </a:ln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CF689BB6-6EF2-1789-6989-828F9ACA7E64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89" t="42958" r="36570" b="35400"/>
          <a:stretch/>
        </p:blipFill>
        <p:spPr>
          <a:xfrm>
            <a:off x="4115472" y="3801608"/>
            <a:ext cx="3324152" cy="1068776"/>
          </a:xfrm>
          <a:prstGeom prst="rect">
            <a:avLst/>
          </a:prstGeom>
          <a:ln>
            <a:noFill/>
          </a:ln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64C1F0D0-E8DD-FEDD-B4C0-010E7522B77E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08" t="68551" r="33690" b="9394"/>
          <a:stretch/>
        </p:blipFill>
        <p:spPr>
          <a:xfrm>
            <a:off x="7748668" y="3778468"/>
            <a:ext cx="3586165" cy="1068775"/>
          </a:xfrm>
          <a:prstGeom prst="rect">
            <a:avLst/>
          </a:prstGeom>
          <a:ln>
            <a:noFill/>
          </a:ln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008CD043-8DFF-6005-E775-004A768860D9}"/>
              </a:ext>
            </a:extLst>
          </p:cNvPr>
          <p:cNvSpPr txBox="1"/>
          <p:nvPr/>
        </p:nvSpPr>
        <p:spPr>
          <a:xfrm>
            <a:off x="416959" y="4966130"/>
            <a:ext cx="3345376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Full unedited gel for </a:t>
            </a:r>
          </a:p>
          <a:p>
            <a:pPr algn="ctr"/>
            <a:r>
              <a:rPr lang="en-US" sz="1200" dirty="0">
                <a:highlight>
                  <a:srgbClr val="00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Supplementary Figure 4C-D (Tubulin, BR1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DC96006E-B8A8-4E72-2997-93AD00AF2235}"/>
              </a:ext>
            </a:extLst>
          </p:cNvPr>
          <p:cNvSpPr txBox="1"/>
          <p:nvPr/>
        </p:nvSpPr>
        <p:spPr>
          <a:xfrm>
            <a:off x="4096332" y="4966130"/>
            <a:ext cx="3345376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C-D (Tubulin, BR2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DC8DEA0-6B74-9A1D-FC03-FB0FB07E4BB1}"/>
              </a:ext>
            </a:extLst>
          </p:cNvPr>
          <p:cNvSpPr txBox="1"/>
          <p:nvPr/>
        </p:nvSpPr>
        <p:spPr>
          <a:xfrm>
            <a:off x="7989457" y="4930505"/>
            <a:ext cx="3345376" cy="461665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Full unedited gel for </a:t>
            </a:r>
          </a:p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C-D (Tubulin, BR3)</a:t>
            </a:r>
          </a:p>
        </p:txBody>
      </p:sp>
      <p:pic>
        <p:nvPicPr>
          <p:cNvPr id="25" name="Picture 24">
            <a:extLst>
              <a:ext uri="{FF2B5EF4-FFF2-40B4-BE49-F238E27FC236}">
                <a16:creationId xmlns:a16="http://schemas.microsoft.com/office/drawing/2014/main" id="{1C8CD8FE-BB73-0BD2-8272-D3A8185E27E8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8708" t="14540" r="24360" b="62467"/>
          <a:stretch/>
        </p:blipFill>
        <p:spPr>
          <a:xfrm>
            <a:off x="416959" y="5460773"/>
            <a:ext cx="3307980" cy="1068777"/>
          </a:xfrm>
          <a:prstGeom prst="rect">
            <a:avLst/>
          </a:prstGeom>
          <a:ln>
            <a:noFill/>
          </a:ln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40C1DD78-E2F8-6D28-1B68-E456684FFFE1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9394" t="39755" r="26180" b="38261"/>
          <a:stretch/>
        </p:blipFill>
        <p:spPr>
          <a:xfrm>
            <a:off x="4131644" y="5460773"/>
            <a:ext cx="3307980" cy="1068777"/>
          </a:xfrm>
          <a:prstGeom prst="rect">
            <a:avLst/>
          </a:prstGeom>
          <a:ln>
            <a:noFill/>
          </a:ln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FC9DC420-B1C7-912B-9CB0-F0DE25B53A6D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15504" t="60840" r="25366" b="16986"/>
          <a:stretch/>
        </p:blipFill>
        <p:spPr>
          <a:xfrm>
            <a:off x="7673876" y="5453724"/>
            <a:ext cx="3586165" cy="1075825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9002425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8</TotalTime>
  <Words>550</Words>
  <Application>Microsoft Office PowerPoint</Application>
  <PresentationFormat>Widescreen</PresentationFormat>
  <Paragraphs>86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dwards, Courtney M</dc:creator>
  <cp:lastModifiedBy>Johnson, Rachelle Whitney</cp:lastModifiedBy>
  <cp:revision>39</cp:revision>
  <dcterms:created xsi:type="dcterms:W3CDTF">2022-11-19T17:18:59Z</dcterms:created>
  <dcterms:modified xsi:type="dcterms:W3CDTF">2023-07-17T15:33:5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792c8cef-6f2b-4af1-b4ac-d815ff795cd6_Enabled">
    <vt:lpwstr>true</vt:lpwstr>
  </property>
  <property fmtid="{D5CDD505-2E9C-101B-9397-08002B2CF9AE}" pid="3" name="MSIP_Label_792c8cef-6f2b-4af1-b4ac-d815ff795cd6_SetDate">
    <vt:lpwstr>2023-07-17T15:33:52Z</vt:lpwstr>
  </property>
  <property fmtid="{D5CDD505-2E9C-101B-9397-08002B2CF9AE}" pid="4" name="MSIP_Label_792c8cef-6f2b-4af1-b4ac-d815ff795cd6_Method">
    <vt:lpwstr>Standard</vt:lpwstr>
  </property>
  <property fmtid="{D5CDD505-2E9C-101B-9397-08002B2CF9AE}" pid="5" name="MSIP_Label_792c8cef-6f2b-4af1-b4ac-d815ff795cd6_Name">
    <vt:lpwstr>VUMC General</vt:lpwstr>
  </property>
  <property fmtid="{D5CDD505-2E9C-101B-9397-08002B2CF9AE}" pid="6" name="MSIP_Label_792c8cef-6f2b-4af1-b4ac-d815ff795cd6_SiteId">
    <vt:lpwstr>ef575030-1424-4ed8-b83c-12c533d879ab</vt:lpwstr>
  </property>
  <property fmtid="{D5CDD505-2E9C-101B-9397-08002B2CF9AE}" pid="7" name="MSIP_Label_792c8cef-6f2b-4af1-b4ac-d815ff795cd6_ActionId">
    <vt:lpwstr>478ada65-4a2c-491c-b568-c247dacf6c3a</vt:lpwstr>
  </property>
  <property fmtid="{D5CDD505-2E9C-101B-9397-08002B2CF9AE}" pid="8" name="MSIP_Label_792c8cef-6f2b-4af1-b4ac-d815ff795cd6_ContentBits">
    <vt:lpwstr>0</vt:lpwstr>
  </property>
</Properties>
</file>